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2" d="100"/>
          <a:sy n="82" d="100"/>
        </p:scale>
        <p:origin x="691"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F50D48-B3A2-43FA-BD8F-00D46BB6E44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0FB3F61-B11B-4B17-9955-0ED069028C4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CB9BF5E-736A-4E82-9EB1-6D79EA4AB8BA}"/>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365C8825-BAFF-4FE3-AEFC-9CCB76A3C12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96B1CE-0929-4D56-AB8F-D7D0E54E63F8}"/>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942864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529453-5A5E-4D20-8FE4-7EE06E400E6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9C16955-99A4-407A-B8A1-B207465B009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519F49-897A-4393-A23F-F1CFC6466183}"/>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626CF001-E612-4A88-8549-9836EB45D4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54DBE1-1929-44C3-8C1D-3C66FE10B8C4}"/>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12990952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0DC8223-EB15-437D-999A-32795F80495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1B043E7-9D1F-484A-BDE1-76BC67109E6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129F74-7D9C-4637-8ACE-C82888559F65}"/>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8E2AB68A-F29B-4D24-967B-B675B24B3AD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DDFBF96-EBB0-4A5C-B445-EC2A915D2855}"/>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28518010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85C7C9-8013-465B-AA03-6E731BDD634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09F766D-C9BC-492B-8C80-646AB337119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5918F0-5F30-491E-947F-C4C99ADD48BB}"/>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BD37B9EC-C3BB-4079-B511-7B44ECFB58A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55A3ED-4253-4149-BCD6-E8859AC82508}"/>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7432082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4A65F7-4A9F-4F42-B750-C394111B039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21D6183-3D49-4FCB-8EE6-2686E761EDA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BC4BB8C-2EA3-49B2-95FE-AD3FD1C14A19}"/>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225B2DE3-F531-45CC-B771-621064C44C8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E085BC-5671-4515-889A-F0E4B043AB6F}"/>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13616890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D07AB6-0E79-4820-88FE-617E0269D0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64762C1-93C5-40A0-8216-148982107F0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92A06B-3FB2-4E01-AB78-62741D233A2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0BBDC6B-CB78-4332-B51B-8DC2CD713BFE}"/>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6" name="Footer Placeholder 5">
            <a:extLst>
              <a:ext uri="{FF2B5EF4-FFF2-40B4-BE49-F238E27FC236}">
                <a16:creationId xmlns:a16="http://schemas.microsoft.com/office/drawing/2014/main" id="{95BB8566-37B7-49E0-AB88-805CC37DE3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4147353-9345-42B8-BDAD-0882D6B5B76C}"/>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39207279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D8BD5A-AE6D-4C76-87E5-50FFC4AE73C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A3D632EF-84A5-4317-B874-554BEBA6AC9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3E5C112-CAF1-4504-98A2-707C8797430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48F2F2B-8A6A-4BF3-B765-EA3C977C93D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29A86C6-DFF1-49F7-8526-247CCEBDFE4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F985D07-F4B2-41AE-9222-CA9E5385D92C}"/>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8" name="Footer Placeholder 7">
            <a:extLst>
              <a:ext uri="{FF2B5EF4-FFF2-40B4-BE49-F238E27FC236}">
                <a16:creationId xmlns:a16="http://schemas.microsoft.com/office/drawing/2014/main" id="{6F65C90C-FE35-44B0-BE3D-BF797046921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7ACEE0A-2582-485E-97FC-CA89970D5ADE}"/>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5135418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30D8BF-6E3F-41E4-BE9F-8A1CEDDD66C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9E5A603-0B08-435D-81D3-6205D4472C6F}"/>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4" name="Footer Placeholder 3">
            <a:extLst>
              <a:ext uri="{FF2B5EF4-FFF2-40B4-BE49-F238E27FC236}">
                <a16:creationId xmlns:a16="http://schemas.microsoft.com/office/drawing/2014/main" id="{5D9E3F0B-FC2D-45E2-BA42-039B5B357CF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DE2E491-FC00-4109-BF5D-AD38A35170B0}"/>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22576495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E7F7241-46CA-42B8-9A35-D4D107D707D8}"/>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3" name="Footer Placeholder 2">
            <a:extLst>
              <a:ext uri="{FF2B5EF4-FFF2-40B4-BE49-F238E27FC236}">
                <a16:creationId xmlns:a16="http://schemas.microsoft.com/office/drawing/2014/main" id="{0EBD7B6F-1242-469A-8EDF-4C98E8D4443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B0F4613-27F3-4889-BEDB-116FBAEB730C}"/>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30043633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1A89DF-DDCB-4629-A499-3F81A873E7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0ECE7C5-CDDC-4F4F-9289-9E43FE9CA4D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06BAD47-D897-4ABA-9E48-7C3309EB7D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B16D137-9FA3-400E-8E83-5D7462E24044}"/>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6" name="Footer Placeholder 5">
            <a:extLst>
              <a:ext uri="{FF2B5EF4-FFF2-40B4-BE49-F238E27FC236}">
                <a16:creationId xmlns:a16="http://schemas.microsoft.com/office/drawing/2014/main" id="{1662B4E9-06C3-407B-B7D1-D50C555177A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0E52C73-B234-4E9F-BD3B-B86D93D0649E}"/>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18497348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C75A13-04ED-41E4-A7F4-E2C4E1FA726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26707EE-5A5E-483A-8167-DA4D373AB3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4D7BD77-A672-4CA0-A5FC-D8382C1CF80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8FA643-C8E5-4B03-BB7E-7F886DFA4199}"/>
              </a:ext>
            </a:extLst>
          </p:cNvPr>
          <p:cNvSpPr>
            <a:spLocks noGrp="1"/>
          </p:cNvSpPr>
          <p:nvPr>
            <p:ph type="dt" sz="half" idx="10"/>
          </p:nvPr>
        </p:nvSpPr>
        <p:spPr/>
        <p:txBody>
          <a:bodyPr/>
          <a:lstStyle/>
          <a:p>
            <a:fld id="{916DC142-9BB7-4197-B8A1-0CCA5FD27E44}" type="datetimeFigureOut">
              <a:rPr lang="en-US" smtClean="0"/>
              <a:t>7/20/2021</a:t>
            </a:fld>
            <a:endParaRPr lang="en-US"/>
          </a:p>
        </p:txBody>
      </p:sp>
      <p:sp>
        <p:nvSpPr>
          <p:cNvPr id="6" name="Footer Placeholder 5">
            <a:extLst>
              <a:ext uri="{FF2B5EF4-FFF2-40B4-BE49-F238E27FC236}">
                <a16:creationId xmlns:a16="http://schemas.microsoft.com/office/drawing/2014/main" id="{33DBDD7C-75A1-4EEF-B2F7-25FB87C1DB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8D91E86-95BD-4860-B1AD-AEB41751C649}"/>
              </a:ext>
            </a:extLst>
          </p:cNvPr>
          <p:cNvSpPr>
            <a:spLocks noGrp="1"/>
          </p:cNvSpPr>
          <p:nvPr>
            <p:ph type="sldNum" sz="quarter" idx="12"/>
          </p:nvPr>
        </p:nvSpPr>
        <p:spPr/>
        <p:txBody>
          <a:bodyPr/>
          <a:lstStyle/>
          <a:p>
            <a:fld id="{6E1283AE-97C6-4933-AB18-C9C80399DE59}" type="slidenum">
              <a:rPr lang="en-US" smtClean="0"/>
              <a:t>‹#›</a:t>
            </a:fld>
            <a:endParaRPr lang="en-US"/>
          </a:p>
        </p:txBody>
      </p:sp>
    </p:spTree>
    <p:extLst>
      <p:ext uri="{BB962C8B-B14F-4D97-AF65-F5344CB8AC3E}">
        <p14:creationId xmlns:p14="http://schemas.microsoft.com/office/powerpoint/2010/main" val="1560869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1164247-601E-4906-B0B5-AFACA36BAE3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8405A3F-B56D-4E4A-9318-7EFCF06BFCC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1A3EDB9-3378-4805-9FB7-A884170FCFD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16DC142-9BB7-4197-B8A1-0CCA5FD27E44}" type="datetimeFigureOut">
              <a:rPr lang="en-US" smtClean="0"/>
              <a:t>7/20/2021</a:t>
            </a:fld>
            <a:endParaRPr lang="en-US"/>
          </a:p>
        </p:txBody>
      </p:sp>
      <p:sp>
        <p:nvSpPr>
          <p:cNvPr id="5" name="Footer Placeholder 4">
            <a:extLst>
              <a:ext uri="{FF2B5EF4-FFF2-40B4-BE49-F238E27FC236}">
                <a16:creationId xmlns:a16="http://schemas.microsoft.com/office/drawing/2014/main" id="{99167C82-3F7F-4CB2-A4EB-AE7812EC408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FE047ED-E872-4873-9D18-84532EA6060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E1283AE-97C6-4933-AB18-C9C80399DE59}" type="slidenum">
              <a:rPr lang="en-US" smtClean="0"/>
              <a:t>‹#›</a:t>
            </a:fld>
            <a:endParaRPr lang="en-US"/>
          </a:p>
        </p:txBody>
      </p:sp>
    </p:spTree>
    <p:extLst>
      <p:ext uri="{BB962C8B-B14F-4D97-AF65-F5344CB8AC3E}">
        <p14:creationId xmlns:p14="http://schemas.microsoft.com/office/powerpoint/2010/main" val="22671428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4A9CBB7-2824-4BEB-9CC2-0B7E6437C61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27786" y="853684"/>
            <a:ext cx="10036629" cy="5467872"/>
          </a:xfrm>
          <a:prstGeom prst="rect">
            <a:avLst/>
          </a:prstGeom>
        </p:spPr>
      </p:pic>
      <p:sp>
        <p:nvSpPr>
          <p:cNvPr id="6" name="TextBox 5">
            <a:extLst>
              <a:ext uri="{FF2B5EF4-FFF2-40B4-BE49-F238E27FC236}">
                <a16:creationId xmlns:a16="http://schemas.microsoft.com/office/drawing/2014/main" id="{C5CAA15A-0051-4073-9EF6-908A33525805}"/>
              </a:ext>
            </a:extLst>
          </p:cNvPr>
          <p:cNvSpPr txBox="1"/>
          <p:nvPr/>
        </p:nvSpPr>
        <p:spPr>
          <a:xfrm>
            <a:off x="0" y="0"/>
            <a:ext cx="12027159" cy="774443"/>
          </a:xfrm>
          <a:prstGeom prst="rect">
            <a:avLst/>
          </a:prstGeom>
          <a:noFill/>
        </p:spPr>
        <p:txBody>
          <a:bodyPr wrap="square">
            <a:spAutoFit/>
          </a:bodyPr>
          <a:lstStyle/>
          <a:p>
            <a:pPr marL="0" marR="0" algn="just">
              <a:lnSpc>
                <a:spcPct val="107000"/>
              </a:lnSpc>
              <a:spcBef>
                <a:spcPts val="0"/>
              </a:spcBef>
              <a:spcAft>
                <a:spcPts val="800"/>
              </a:spcAft>
            </a:pPr>
            <a:r>
              <a:rPr lang="en-US" sz="1200" b="1" dirty="0">
                <a:effectLst/>
                <a:latin typeface="Times New Roman" panose="02020603050405020304" pitchFamily="18" charset="0"/>
                <a:ea typeface="Calibri" panose="020F0502020204030204" pitchFamily="34" charset="0"/>
              </a:rPr>
              <a:t>Supplementary Figure 1</a:t>
            </a:r>
            <a:endParaRPr lang="en-US" sz="1200" dirty="0">
              <a:effectLst/>
              <a:latin typeface="Times New Roman" panose="02020603050405020304" pitchFamily="18" charset="0"/>
              <a:ea typeface="Calibri" panose="020F0502020204030204" pitchFamily="34" charset="0"/>
            </a:endParaRPr>
          </a:p>
          <a:p>
            <a:pPr marL="0" marR="0" algn="just">
              <a:lnSpc>
                <a:spcPct val="107000"/>
              </a:lnSpc>
              <a:spcBef>
                <a:spcPts val="0"/>
              </a:spcBef>
              <a:spcAft>
                <a:spcPts val="800"/>
              </a:spcAft>
            </a:pPr>
            <a:r>
              <a:rPr lang="en-US" sz="1200" dirty="0">
                <a:effectLst/>
                <a:latin typeface="Times New Roman" panose="02020603050405020304" pitchFamily="18" charset="0"/>
                <a:ea typeface="Calibri" panose="020F0502020204030204" pitchFamily="34" charset="0"/>
              </a:rPr>
              <a:t>Principal component analysis of virus proteins. Analysis reveals Met, Gln, Trp, and Thr are grouped together. Amino acid Ile and Asn also clustered together. The amino acids of land plants and vertebrates cluster together showing their close correlation. PCA was conducted using statistical software Unscrambler 0.14.1.0.</a:t>
            </a:r>
          </a:p>
        </p:txBody>
      </p:sp>
    </p:spTree>
    <p:extLst>
      <p:ext uri="{BB962C8B-B14F-4D97-AF65-F5344CB8AC3E}">
        <p14:creationId xmlns:p14="http://schemas.microsoft.com/office/powerpoint/2010/main" val="31459959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57</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hanta Tapan</dc:creator>
  <cp:lastModifiedBy>HP</cp:lastModifiedBy>
  <cp:revision>2</cp:revision>
  <dcterms:created xsi:type="dcterms:W3CDTF">2021-04-07T06:11:48Z</dcterms:created>
  <dcterms:modified xsi:type="dcterms:W3CDTF">2021-07-20T04:49:07Z</dcterms:modified>
</cp:coreProperties>
</file>